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custDataLst>
    <p:tags r:id="rId2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4" Type="http://schemas.openxmlformats.org/officeDocument/2006/relationships/tags" Target="tags/tag1.xml"/><Relationship Id="rId23" Type="http://schemas.openxmlformats.org/officeDocument/2006/relationships/tableStyles" Target="tableStyles.xml"/><Relationship Id="rId22" Type="http://schemas.openxmlformats.org/officeDocument/2006/relationships/viewProps" Target="viewProps.xml"/><Relationship Id="rId21" Type="http://schemas.openxmlformats.org/officeDocument/2006/relationships/presProps" Target="presProps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3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4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5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6.pn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7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-Oxocarboxylic acid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74620" y="0"/>
            <a:ext cx="614934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Cysteine and methion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95600" y="0"/>
            <a:ext cx="640080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lycine, serine and threon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45690" y="0"/>
            <a:ext cx="750062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lyoxylate and dicarboxylat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40510" y="0"/>
            <a:ext cx="911034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Histid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2075" y="0"/>
            <a:ext cx="1209992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Linoleic acid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92175" y="0"/>
            <a:ext cx="1040765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Nicotinate and nicotinamid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58900" y="0"/>
            <a:ext cx="947483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Phenylalan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35990" y="0"/>
            <a:ext cx="1032002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Phenylalanine, tyrosine and tryptophan biosynthesi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84170" y="0"/>
            <a:ext cx="642302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Thiam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82165" y="0"/>
            <a:ext cx="802830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lanine, aspartate and glutamat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81580" y="0"/>
            <a:ext cx="760349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minoacyl-tRNA biosynthesi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209290" y="0"/>
            <a:ext cx="577342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rachidonic acid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12192000" cy="649605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rginine and prol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14425" y="0"/>
            <a:ext cx="1009713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rginine biosynthesi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12192000" cy="5099685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beta-Alanine metabolis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50645" y="60325"/>
            <a:ext cx="949134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Biosynthesis of amino acids (2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23515" y="0"/>
            <a:ext cx="674497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Biosynthesis of amino acid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64460" y="0"/>
            <a:ext cx="6744970" cy="6858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Tg2Yzg2MjQ4ZWNiZTRlZjFjNGU2MWU3MmFlNDJjM2YifQ=="/>
</p:tagLst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WPS 演示</Application>
  <PresentationFormat>宽屏</PresentationFormat>
  <Paragraphs>0</Paragraphs>
  <Slides>1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5" baseType="lpstr">
      <vt:lpstr>Arial</vt:lpstr>
      <vt:lpstr>宋体</vt:lpstr>
      <vt:lpstr>Wingdings</vt:lpstr>
      <vt:lpstr>Arial Unicode MS</vt:lpstr>
      <vt:lpstr>Calibri</vt:lpstr>
      <vt:lpstr>微软雅黑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</dc:creator>
  <cp:lastModifiedBy>戴鹏秀</cp:lastModifiedBy>
  <cp:revision>2</cp:revision>
  <dcterms:created xsi:type="dcterms:W3CDTF">2023-10-25T12:00:00Z</dcterms:created>
  <dcterms:modified xsi:type="dcterms:W3CDTF">2023-10-25T12:05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B9F21FFD8F94581A63C71385AF2BC0C_12</vt:lpwstr>
  </property>
  <property fmtid="{D5CDD505-2E9C-101B-9397-08002B2CF9AE}" pid="3" name="KSOProductBuildVer">
    <vt:lpwstr>2052-12.1.0.15712</vt:lpwstr>
  </property>
</Properties>
</file>